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255D2-CF5E-482E-86A1-266A73D711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50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9D00C-CBDB-44CB-ADA6-EB9A386F5F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EA8C7-A377-4295-A839-2F7BA8650C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06D64-997F-4733-9C0F-399252F76B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24"/>
              </a:spcBef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3FF15-10F0-4CB7-9953-51F24B9D35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D99E2-8A52-4A51-A085-C3235C05AA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ECDF0E-BF8C-4ECB-8225-E4DFD574BF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3157DC-63DB-4A55-B52F-EA3E3A838C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24"/>
              </a:spcBef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8633F-5823-416E-A8FC-12AB742FD6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BAE21-B092-4F6C-A285-6864A80D0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F9487-77C8-47D0-820D-DD308130D2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E146D-EAE5-41E6-9EAF-00C4730EF4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ctr">
            <a:noAutofit/>
          </a:bodyPr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rmAutofit fontScale="95000"/>
          </a:bodyPr>
          <a:p>
            <a:pPr marL="372240" indent="-37224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1" marL="806760" indent="-31032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2" marL="1240920" indent="-24696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3" marL="1737360" indent="-24696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4" marL="2233440" indent="-24696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5" marL="2233440" indent="-24696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6" marL="2233440" indent="-24696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63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Autofit/>
          </a:bodyPr>
          <a:lstStyle>
            <a:lvl1pPr indent="0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  <a:defRPr b="0" lang="en-US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636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Autofit/>
          </a:bodyPr>
          <a:lstStyle>
            <a:lvl1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  <a:defRPr b="0" lang="en-US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63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104400" rIns="104400" tIns="52200" bIns="52200" anchor="t">
            <a:noAutofit/>
          </a:bodyPr>
          <a:lstStyle>
            <a:lvl1pPr indent="0" algn="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  <a:defRPr b="0" lang="en-US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fld id="{804B567C-748D-4EC3-9FF6-4435E966D7EA}" type="slidenum">
              <a:rPr b="0" lang="en-US" sz="1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304920"/>
            <a:ext cx="876312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TTGGTGACTGAT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T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</a:t>
            </a:r>
            <a:r>
              <a:rPr b="1" lang="en-US" sz="1800" spc="-1" strike="noStrike">
                <a:solidFill>
                  <a:srgbClr val="6600cc"/>
                </a:solidFill>
                <a:latin typeface="Courier New"/>
              </a:rPr>
              <a:t>gtgagt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aaataacactagttactagttatggattattattttaattgggc</a:t>
            </a:r>
            <a:r>
              <a:rPr b="1" lang="en-US" sz="1800" spc="-1" strike="noStrike">
                <a:solidFill>
                  <a:srgbClr val="6600cc"/>
                </a:solidFill>
                <a:latin typeface="Courier New"/>
              </a:rPr>
              <a:t>aattaatta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agagtaggttataataaaagaattccatggg</a:t>
            </a:r>
            <a:r>
              <a:rPr b="1" lang="en-US" sz="1800" spc="-1" strike="noStrike">
                <a:solidFill>
                  <a:srgbClr val="6600cc"/>
                </a:solidFill>
                <a:latin typeface="Courier New"/>
              </a:rPr>
              <a:t>ca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G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CCA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AT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GTG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T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AAAAA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AACAGT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T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GC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T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TT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ACAAT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T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CC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CA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T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GGGAGAGTGG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A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748320" y="1981080"/>
            <a:ext cx="172152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Leafy spurge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66760" y="3048120"/>
            <a:ext cx="86868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TTGGTGACTGAT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T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CT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</a:t>
            </a:r>
            <a:r>
              <a:rPr b="1" lang="en-US" sz="1800" spc="-1" strike="noStrike">
                <a:solidFill>
                  <a:srgbClr val="6600cc"/>
                </a:solidFill>
                <a:latin typeface="Courier New"/>
              </a:rPr>
              <a:t>gtgagt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tttattctatatattagatcgctaggtgttagaaatatagaaaggtatatgaaatagcct</a:t>
            </a:r>
            <a:r>
              <a:rPr b="1" lang="en-US" sz="1800" spc="-1" strike="noStrike">
                <a:solidFill>
                  <a:srgbClr val="6600cc"/>
                </a:solidFill>
                <a:latin typeface="Courier New"/>
              </a:rPr>
              <a:t>aattaatta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gttactagctagaaaattcacatgttttgatgaactttttattttt</a:t>
            </a:r>
            <a:r>
              <a:rPr b="1" lang="en-US" sz="1800" spc="-1" strike="noStrike">
                <a:solidFill>
                  <a:srgbClr val="6600cc"/>
                </a:solidFill>
                <a:latin typeface="Courier New"/>
              </a:rPr>
              <a:t>ca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G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CCA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GC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G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GTG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T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CTTGG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AACAGT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T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GC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CT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TT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ACAAT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C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C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CCGC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T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C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ACA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TGT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AGGGAGAGTGG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CG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6600cc"/>
                </a:solidFill>
                <a:latin typeface="Courier New"/>
              </a:rPr>
              <a:t>GGAAG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01960" y="4952880"/>
            <a:ext cx="161604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1046160"/>
                <a:tab algn="l" pos="2092320"/>
                <a:tab algn="l" pos="3138480"/>
                <a:tab algn="l" pos="4184640"/>
                <a:tab algn="l" pos="5230800"/>
                <a:tab algn="l" pos="6276960"/>
                <a:tab algn="l" pos="7323120"/>
                <a:tab algn="l" pos="8369280"/>
                <a:tab algn="l" pos="9415440"/>
                <a:tab algn="l" pos="104616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Arabidopsis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3T20:06:12Z</dcterms:created>
  <dc:creator>David Horvath</dc:creator>
  <dc:description/>
  <dc:language>en-US</dc:language>
  <cp:lastModifiedBy>David Horvath</cp:lastModifiedBy>
  <dcterms:modified xsi:type="dcterms:W3CDTF">2008-11-11T19:38:31Z</dcterms:modified>
  <cp:revision>19</cp:revision>
  <dc:subject/>
  <dc:title>Slide 1</dc:title>
</cp:coreProperties>
</file>